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  <p:sldId id="292" r:id="rId3"/>
    <p:sldId id="289" r:id="rId4"/>
    <p:sldId id="294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697497-8CDC-46D0-A9AB-F7253B3EC6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9266AFD-A327-45E7-9B72-CB260D053B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55D7F0A-43FC-4DEC-8729-993204EA7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690514F-AFC0-4BF7-8B07-E16687363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C2D2B9A-EEFA-495D-8DA4-5B0DC9219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060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56FD3C8-6BD7-47EA-BA18-18DA12AE9F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0DF8E9B-96A9-40FC-9834-454F6AD937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1D71F75-D2ED-4EC2-A352-8DEC26CF1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EEACCA0-7D3F-4757-BFE5-AFA533057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F54D92F-5734-4FF4-BB92-F388B306F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8200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4F44E35-8902-42F4-B914-11FF14F787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ABAE6C9-5BCA-42D6-99A5-61F87A9661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835047-4251-4FAF-8734-5C8B48A89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3C6B9CB-C65D-4214-82B2-6EB02F03F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1FE0BCD-4F89-4E8B-BCAD-B0628DF04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0541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52F845-6535-4B10-A329-74C913D3A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6E3FC8F-4F73-41EC-9BAE-0872ABB394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787D63-3E74-41C1-B1C6-E5DDBCF3D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0296809-50BC-4E97-BE7A-0D4BF1C9F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3D72D5-6BA5-494A-B59E-E9E66F088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031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DA0C2FC-CF7B-4D63-ACC7-B6AE4B1CC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987D289-F7A7-4463-B91A-5CCD6B22C5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819BB72-D155-41AF-9117-1D89C27A7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FDA2B82-A8BB-4F3E-8FA7-92DCEBD23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3524C8-59E6-49C5-9E50-F1B55797F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255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293AAC-8517-437D-B86A-D9FCCB812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89C8676-7AF3-4697-A07E-481222624A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6044625-C468-4D84-AB16-6AACEDCB9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EA05864-D8C4-42F8-A286-31E252F0F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AA1A6AA-6FC8-43B3-9422-0DE8A9B67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8B70C9B-388F-4D08-98B5-827A9B498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528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410DDE-6236-48C5-B1EC-50EE6027E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D7A74-351F-4F77-95CE-2C29D2BBBC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95DEA8C-9A01-40B9-9320-F477F65256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99A485A-1161-44FF-8956-5FC0D9CD5D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2E8C665-7DCB-49BB-B587-402CFAE82A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3B5A351-AF6F-47BA-ACCC-A01CA9EE1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AE76783-B028-4126-A263-D8040769C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B7854C8-D59E-4C76-8069-CD57D0DE3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1742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44D2E1-B158-4937-B6E6-AE5B8894B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2E32FC5-942D-4F3F-9ED5-B5EE2EE83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4ABEC1A-0C83-4415-AA58-6C4B19C8F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74DC2DA-F524-4501-94B5-5147B35DB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195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A91D8B3-359C-493A-9CE8-93DB9FA43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7230F12-C220-4252-B05E-2FE53A5EE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E148922-14D0-40BA-89BD-E54A2B6BB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4695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A8091A1-B603-4E58-AA20-F7F172C3A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030A39F-A0D9-4BEE-9CE9-75D7392459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B321EE0-0233-465E-AC32-F66A39518D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AAC7DE-6257-4D07-BCA4-0CEF6A846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CE9069B-B6A2-405B-85D3-AE24F6300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3E31361-9BD0-4F90-ABC9-F04AB0CD5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9848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D37263-A6CA-458E-BA96-E1A6E7969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6AA8E84-612C-460F-BAC9-BF8B8A16F9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4533744-D499-4493-9326-19F1318C81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D735996-C6B7-497F-812B-607D9026F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928B699-005D-4FC2-B8F9-C40CA4901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FBA1A73-1638-4436-93A2-D81A4DD68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442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5C6C1AE-943F-47F1-B77A-08B17EED0C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62452F7-F332-47F1-9842-94B29F3C01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E84D16A-2A03-42F9-9F83-88437CA9F4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69306-EE3C-4E37-B851-4F3FDBC60E8E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8846D8D-65C2-42A5-8215-BC9D4E13E2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9680D9D-0C73-457A-9244-835C38C95B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55E38-A46D-4D8C-A27C-E6A27F00EB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4979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0.wdp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A0EE9F69-3EA9-4738-B731-657BDD98C604}"/>
              </a:ext>
            </a:extLst>
          </p:cNvPr>
          <p:cNvSpPr/>
          <p:nvPr/>
        </p:nvSpPr>
        <p:spPr>
          <a:xfrm>
            <a:off x="6816" y="3667523"/>
            <a:ext cx="11995714" cy="21852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>
              <a:lnSpc>
                <a:spcPct val="200000"/>
              </a:lnSpc>
            </a:pPr>
            <a:r>
              <a:rPr lang="en-US" altLang="ko-KR" sz="17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1. (A-E) Structure and chromatogram of ginsenoside Rg1, Rb1 and Rg3 in PG and tannic acid in DKL respectively.</a:t>
            </a:r>
            <a:endParaRPr lang="en-US" altLang="ko-KR" sz="1700" dirty="0"/>
          </a:p>
          <a:p>
            <a:pPr latinLnBrk="0">
              <a:lnSpc>
                <a:spcPct val="200000"/>
              </a:lnSpc>
            </a:pPr>
            <a:r>
              <a:rPr lang="en-US" altLang="ko-KR" sz="17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2. (A-B) Chromatogram of ginsenoside Rg1, Rb1 and Rg3 and tannic acid in mixture PG and DKL (1:3) respectively.</a:t>
            </a:r>
          </a:p>
          <a:p>
            <a:pPr latinLnBrk="0">
              <a:lnSpc>
                <a:spcPct val="200000"/>
              </a:lnSpc>
            </a:pPr>
            <a:r>
              <a:rPr lang="en-US" altLang="ko-KR" sz="17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3. The measurement of food intake in vehicle and 200 mg/kg mixture of PG and DKL (1:3)-administered NCD mice and in vehicle and 50, 100 and 200 mg/kg mixture of PG and DKL (1:3)-administered HFD mice during 9 weeks </a:t>
            </a:r>
            <a:endParaRPr lang="ko-KR" altLang="ko-KR" sz="1700" dirty="0">
              <a:effectLst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DFDA1F98-D44C-470F-813B-B59E3EC44487}"/>
              </a:ext>
            </a:extLst>
          </p:cNvPr>
          <p:cNvSpPr/>
          <p:nvPr/>
        </p:nvSpPr>
        <p:spPr>
          <a:xfrm>
            <a:off x="102066" y="76118"/>
            <a:ext cx="11987868" cy="32391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0"/>
              </a:spcAft>
            </a:pPr>
            <a:r>
              <a:rPr lang="en-US" altLang="ko-KR" sz="20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bination of </a:t>
            </a:r>
            <a:r>
              <a:rPr lang="en-US" altLang="ko-KR" sz="2000" b="1" i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nax ginseng</a:t>
            </a:r>
            <a:r>
              <a:rPr lang="en-US" altLang="ko-KR" sz="20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2000" b="1" i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ospyros kaki </a:t>
            </a:r>
            <a:r>
              <a:rPr lang="en-US" altLang="ko-KR" sz="20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af inhibits white adipocyte differentiation and browning process through AMP-Activated Protein Kinase (AMPK) Activation </a:t>
            </a:r>
            <a:r>
              <a:rPr lang="en-US" altLang="ko-KR" sz="2000" b="1" i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altLang="ko-KR" sz="20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2000" b="1" i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endParaRPr lang="ko-KR" altLang="ko-KR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wa-Young Lee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um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wa Lee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wa-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oung Jae L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o Mi Ko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o-Sung K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e Won K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e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yung K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e Young Kim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e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 Hwang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a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young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oi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o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 Ju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, Kyung hyu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, Han-Jung Chae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5,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liverRM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Non-Clinical Evaluation Center Biomedical Research Institute,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National University Hospital,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ju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54907, 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outh Korea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; </a:t>
            </a:r>
            <a:r>
              <a:rPr lang="en-US" altLang="ko-KR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Research Institute of Clinical Medicine of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National University-Biomedical Research Institute of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National University Hospital,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ju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54907, Republic of Korea; </a:t>
            </a:r>
            <a:r>
              <a:rPr lang="en-US" altLang="ko-KR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College of Pharmacy, </a:t>
            </a:r>
            <a:r>
              <a:rPr lang="en-US" altLang="ko-KR" sz="140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Kyungsung</a:t>
            </a:r>
            <a:r>
              <a:rPr lang="en-US" altLang="ko-KR" sz="14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 University 309 </a:t>
            </a:r>
            <a:r>
              <a:rPr lang="en-US" altLang="ko-KR" sz="140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Suyeong-ro</a:t>
            </a:r>
            <a:r>
              <a:rPr lang="en-US" altLang="ko-KR" sz="14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, Nam-</a:t>
            </a:r>
            <a:r>
              <a:rPr lang="en-US" altLang="ko-KR" sz="140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gu</a:t>
            </a:r>
            <a:r>
              <a:rPr lang="en-US" altLang="ko-KR" sz="14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궁서" panose="02030600000101010101" pitchFamily="18" charset="-127"/>
                <a:cs typeface="Times New Roman" panose="02020603050405020304" pitchFamily="18" charset="0"/>
              </a:rPr>
              <a:t>, Busan 48434, Republic of Korea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; 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itute of Jinan Red Ginseng, Jinan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5442, Republic of Korea; 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of Pharmacy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ju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buk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4896, Republic of Korea</a:t>
            </a:r>
          </a:p>
          <a:p>
            <a:pPr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: hjchael@jbnu.ac.kr; Tel.: 82-63-270-3092, khmin1492@jbnu.ac.kr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3426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EBDF576-F90C-48CF-9058-AE2E66154829}"/>
              </a:ext>
            </a:extLst>
          </p:cNvPr>
          <p:cNvSpPr txBox="1"/>
          <p:nvPr/>
        </p:nvSpPr>
        <p:spPr>
          <a:xfrm>
            <a:off x="49766" y="68411"/>
            <a:ext cx="3546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CD33F85-6DC3-4BFA-856B-7D1A2FD12332}"/>
              </a:ext>
            </a:extLst>
          </p:cNvPr>
          <p:cNvSpPr txBox="1"/>
          <p:nvPr/>
        </p:nvSpPr>
        <p:spPr>
          <a:xfrm>
            <a:off x="1036863" y="2096926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BE2D9979-0AE7-486E-B8D7-9B21A18E0E23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14502" y="2610445"/>
            <a:ext cx="3304082" cy="1886263"/>
          </a:xfrm>
          <a:prstGeom prst="rect">
            <a:avLst/>
          </a:prstGeom>
        </p:spPr>
      </p:pic>
      <p:sp>
        <p:nvSpPr>
          <p:cNvPr id="15" name="아래쪽 화살표 27">
            <a:extLst>
              <a:ext uri="{FF2B5EF4-FFF2-40B4-BE49-F238E27FC236}">
                <a16:creationId xmlns:a16="http://schemas.microsoft.com/office/drawing/2014/main" id="{4A5ECAEC-7DD5-48EA-984B-7AA5624C39CB}"/>
              </a:ext>
            </a:extLst>
          </p:cNvPr>
          <p:cNvSpPr/>
          <p:nvPr/>
        </p:nvSpPr>
        <p:spPr>
          <a:xfrm>
            <a:off x="3138692" y="2821399"/>
            <a:ext cx="89778" cy="21060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D38BDA5-EF80-494E-919E-CA4274EA0F24}"/>
              </a:ext>
            </a:extLst>
          </p:cNvPr>
          <p:cNvSpPr txBox="1"/>
          <p:nvPr/>
        </p:nvSpPr>
        <p:spPr>
          <a:xfrm>
            <a:off x="1943887" y="2216062"/>
            <a:ext cx="16025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g1</a:t>
            </a:r>
            <a:endParaRPr lang="ko-KR" altLang="en-US" sz="1100" b="1" dirty="0"/>
          </a:p>
        </p:txBody>
      </p:sp>
      <p:sp>
        <p:nvSpPr>
          <p:cNvPr id="17" name="아래쪽 화살표 29">
            <a:extLst>
              <a:ext uri="{FF2B5EF4-FFF2-40B4-BE49-F238E27FC236}">
                <a16:creationId xmlns:a16="http://schemas.microsoft.com/office/drawing/2014/main" id="{CCFCAB5C-36CF-48ED-ACCE-8A0B138F9239}"/>
              </a:ext>
            </a:extLst>
          </p:cNvPr>
          <p:cNvSpPr/>
          <p:nvPr/>
        </p:nvSpPr>
        <p:spPr>
          <a:xfrm>
            <a:off x="2597613" y="2476384"/>
            <a:ext cx="112963" cy="191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53C76A-4A36-4D8A-B203-7CC99A48AF2C}"/>
              </a:ext>
            </a:extLst>
          </p:cNvPr>
          <p:cNvSpPr txBox="1"/>
          <p:nvPr/>
        </p:nvSpPr>
        <p:spPr>
          <a:xfrm>
            <a:off x="2646473" y="2527241"/>
            <a:ext cx="16141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b1</a:t>
            </a:r>
            <a:endParaRPr lang="ko-KR" altLang="en-US" sz="11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0C52C7-0A90-4135-ABC5-7131E5468F27}"/>
              </a:ext>
            </a:extLst>
          </p:cNvPr>
          <p:cNvSpPr txBox="1"/>
          <p:nvPr/>
        </p:nvSpPr>
        <p:spPr>
          <a:xfrm>
            <a:off x="3375030" y="2314495"/>
            <a:ext cx="16025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g3</a:t>
            </a:r>
            <a:endParaRPr lang="ko-KR" altLang="en-US" sz="1100" b="1" dirty="0"/>
          </a:p>
        </p:txBody>
      </p:sp>
      <p:sp>
        <p:nvSpPr>
          <p:cNvPr id="20" name="아래쪽 화살표 24">
            <a:extLst>
              <a:ext uri="{FF2B5EF4-FFF2-40B4-BE49-F238E27FC236}">
                <a16:creationId xmlns:a16="http://schemas.microsoft.com/office/drawing/2014/main" id="{5DF34564-8E4C-488E-B54D-D50AC4137D6B}"/>
              </a:ext>
            </a:extLst>
          </p:cNvPr>
          <p:cNvSpPr/>
          <p:nvPr/>
        </p:nvSpPr>
        <p:spPr>
          <a:xfrm>
            <a:off x="3981131" y="2536716"/>
            <a:ext cx="112963" cy="191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9" name="Picture 2" descr="Ginsenoside Rg1 primary reference standard">
            <a:extLst>
              <a:ext uri="{FF2B5EF4-FFF2-40B4-BE49-F238E27FC236}">
                <a16:creationId xmlns:a16="http://schemas.microsoft.com/office/drawing/2014/main" id="{7FFDCAB3-6EB5-48D4-B6D7-DC97324366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5332" y="786818"/>
            <a:ext cx="1643730" cy="12031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4" descr="Ginsenoside Rb1 primary reference standard">
            <a:extLst>
              <a:ext uri="{FF2B5EF4-FFF2-40B4-BE49-F238E27FC236}">
                <a16:creationId xmlns:a16="http://schemas.microsoft.com/office/drawing/2014/main" id="{9E252E74-8B2C-47F8-8AF1-63546EE08E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8069" y="600492"/>
            <a:ext cx="1638721" cy="13010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6" descr="Ginsenoside Rg3 &amp;#8805;98% (HPLC)">
            <a:extLst>
              <a:ext uri="{FF2B5EF4-FFF2-40B4-BE49-F238E27FC236}">
                <a16:creationId xmlns:a16="http://schemas.microsoft.com/office/drawing/2014/main" id="{8B358556-7D7C-4A2A-AABD-D64F45CB30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5771" y="597895"/>
            <a:ext cx="1762153" cy="13577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B2A82AB2-3451-4DA0-8E7A-1D8E6551ABC4}"/>
              </a:ext>
            </a:extLst>
          </p:cNvPr>
          <p:cNvSpPr txBox="1"/>
          <p:nvPr/>
        </p:nvSpPr>
        <p:spPr>
          <a:xfrm>
            <a:off x="3801221" y="1647795"/>
            <a:ext cx="2804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err="1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Ginsenoside</a:t>
            </a:r>
            <a:r>
              <a:rPr lang="en-US" altLang="ko-KR" sz="1400" dirty="0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 Rb1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44D9A56-347E-4F81-9EA4-BE8C4E479701}"/>
              </a:ext>
            </a:extLst>
          </p:cNvPr>
          <p:cNvSpPr txBox="1"/>
          <p:nvPr/>
        </p:nvSpPr>
        <p:spPr>
          <a:xfrm>
            <a:off x="5850834" y="1579743"/>
            <a:ext cx="2804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err="1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Ginsenoside</a:t>
            </a:r>
            <a:r>
              <a:rPr lang="en-US" altLang="ko-KR" sz="1400" dirty="0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 Rg3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9A498AF-2A0B-40B4-8D96-12E25AED8B7A}"/>
              </a:ext>
            </a:extLst>
          </p:cNvPr>
          <p:cNvSpPr txBox="1"/>
          <p:nvPr/>
        </p:nvSpPr>
        <p:spPr>
          <a:xfrm>
            <a:off x="1036863" y="536947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E00D725-37D4-4522-BD04-95AE82981BBB}"/>
              </a:ext>
            </a:extLst>
          </p:cNvPr>
          <p:cNvSpPr txBox="1"/>
          <p:nvPr/>
        </p:nvSpPr>
        <p:spPr>
          <a:xfrm>
            <a:off x="1435331" y="1682186"/>
            <a:ext cx="2804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err="1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Ginsenoside</a:t>
            </a:r>
            <a:r>
              <a:rPr lang="en-US" altLang="ko-KR" sz="1400" dirty="0">
                <a:latin typeface="Times New Roman" panose="02020603050405020304" pitchFamily="18" charset="0"/>
                <a:ea typeface="HY헤드라인M" pitchFamily="18" charset="-127"/>
                <a:cs typeface="Times New Roman" panose="02020603050405020304" pitchFamily="18" charset="0"/>
              </a:rPr>
              <a:t> Rg1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그림 27">
            <a:extLst>
              <a:ext uri="{FF2B5EF4-FFF2-40B4-BE49-F238E27FC236}">
                <a16:creationId xmlns:a16="http://schemas.microsoft.com/office/drawing/2014/main" id="{4829449E-6420-47BE-B1F3-37AB4CD9D3C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80000"/>
                    </a14:imgEffect>
                    <a14:imgEffect>
                      <a14:brightnessContrast bright="-6000" contrast="5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0200" y="478997"/>
            <a:ext cx="2049684" cy="1595523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345B599-56E5-4C70-8721-A624E2E439E6}"/>
              </a:ext>
            </a:extLst>
          </p:cNvPr>
          <p:cNvSpPr txBox="1"/>
          <p:nvPr/>
        </p:nvSpPr>
        <p:spPr>
          <a:xfrm>
            <a:off x="9512751" y="1666845"/>
            <a:ext cx="13647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nnic acid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210DAB1B-72CA-4705-B6FC-519D034BD9D8}"/>
              </a:ext>
            </a:extLst>
          </p:cNvPr>
          <p:cNvGrpSpPr/>
          <p:nvPr/>
        </p:nvGrpSpPr>
        <p:grpSpPr>
          <a:xfrm>
            <a:off x="6363863" y="2263524"/>
            <a:ext cx="4159803" cy="2255027"/>
            <a:chOff x="4696068" y="2722011"/>
            <a:chExt cx="5012878" cy="2592000"/>
          </a:xfrm>
        </p:grpSpPr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4D8EC9B8-C4F0-456C-B29E-6A6FF5A8C597}"/>
                </a:ext>
              </a:extLst>
            </p:cNvPr>
            <p:cNvPicPr>
              <a:picLocks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696068" y="2722011"/>
              <a:ext cx="4752000" cy="2592000"/>
            </a:xfrm>
            <a:prstGeom prst="rect">
              <a:avLst/>
            </a:prstGeom>
          </p:spPr>
        </p:pic>
        <p:sp>
          <p:nvSpPr>
            <p:cNvPr id="32" name="아래쪽 화살표 23">
              <a:extLst>
                <a:ext uri="{FF2B5EF4-FFF2-40B4-BE49-F238E27FC236}">
                  <a16:creationId xmlns:a16="http://schemas.microsoft.com/office/drawing/2014/main" id="{F4C0D876-E2F6-4E56-B653-E15D3F4289C0}"/>
                </a:ext>
              </a:extLst>
            </p:cNvPr>
            <p:cNvSpPr/>
            <p:nvPr/>
          </p:nvSpPr>
          <p:spPr>
            <a:xfrm>
              <a:off x="7155321" y="4473162"/>
              <a:ext cx="89778" cy="280317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16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B235E78-A321-4005-8500-1F45DCE1326A}"/>
                </a:ext>
              </a:extLst>
            </p:cNvPr>
            <p:cNvSpPr txBox="1"/>
            <p:nvPr/>
          </p:nvSpPr>
          <p:spPr>
            <a:xfrm>
              <a:off x="5253424" y="4280461"/>
              <a:ext cx="17716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err="1"/>
                <a:t>Ginsenoside</a:t>
              </a:r>
              <a:r>
                <a:rPr lang="en-US" altLang="ko-KR" sz="1100" b="1" dirty="0"/>
                <a:t> Rg1</a:t>
              </a:r>
              <a:endParaRPr lang="ko-KR" altLang="en-US" sz="1100" b="1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DB31B90-B22C-4C83-9D66-FED33207ED21}"/>
                </a:ext>
              </a:extLst>
            </p:cNvPr>
            <p:cNvSpPr txBox="1"/>
            <p:nvPr/>
          </p:nvSpPr>
          <p:spPr>
            <a:xfrm>
              <a:off x="6647765" y="4165204"/>
              <a:ext cx="19984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err="1"/>
                <a:t>Ginsenoside</a:t>
              </a:r>
              <a:r>
                <a:rPr lang="en-US" altLang="ko-KR" sz="1100" b="1" dirty="0"/>
                <a:t> Rb1</a:t>
              </a:r>
              <a:endParaRPr lang="ko-KR" altLang="en-US" sz="1100" b="1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19A1982-9C3E-4C59-8A95-E31B810EFEF3}"/>
                </a:ext>
              </a:extLst>
            </p:cNvPr>
            <p:cNvSpPr txBox="1"/>
            <p:nvPr/>
          </p:nvSpPr>
          <p:spPr>
            <a:xfrm>
              <a:off x="8031431" y="4272865"/>
              <a:ext cx="16775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err="1"/>
                <a:t>Ginsenoside</a:t>
              </a:r>
              <a:r>
                <a:rPr lang="en-US" altLang="ko-KR" sz="1100" b="1" dirty="0"/>
                <a:t> Rg3</a:t>
              </a:r>
              <a:endParaRPr lang="ko-KR" altLang="en-US" sz="1100" b="1" dirty="0"/>
            </a:p>
          </p:txBody>
        </p:sp>
        <p:sp>
          <p:nvSpPr>
            <p:cNvPr id="36" name="아래쪽 화살표 35">
              <a:extLst>
                <a:ext uri="{FF2B5EF4-FFF2-40B4-BE49-F238E27FC236}">
                  <a16:creationId xmlns:a16="http://schemas.microsoft.com/office/drawing/2014/main" id="{A89E27CA-C6CA-4F2F-94A6-089CA7204C91}"/>
                </a:ext>
              </a:extLst>
            </p:cNvPr>
            <p:cNvSpPr/>
            <p:nvPr/>
          </p:nvSpPr>
          <p:spPr>
            <a:xfrm>
              <a:off x="8389694" y="4536432"/>
              <a:ext cx="102693" cy="254988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160"/>
            </a:p>
          </p:txBody>
        </p:sp>
        <p:sp>
          <p:nvSpPr>
            <p:cNvPr id="37" name="아래쪽 화살표 36">
              <a:extLst>
                <a:ext uri="{FF2B5EF4-FFF2-40B4-BE49-F238E27FC236}">
                  <a16:creationId xmlns:a16="http://schemas.microsoft.com/office/drawing/2014/main" id="{9FA311C9-41D9-412D-8468-E8486419A0E0}"/>
                </a:ext>
              </a:extLst>
            </p:cNvPr>
            <p:cNvSpPr/>
            <p:nvPr/>
          </p:nvSpPr>
          <p:spPr>
            <a:xfrm>
              <a:off x="6432851" y="4549851"/>
              <a:ext cx="89778" cy="231667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160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DCD33F85-6DC3-4BFA-856B-7D1A2FD12332}"/>
              </a:ext>
            </a:extLst>
          </p:cNvPr>
          <p:cNvSpPr txBox="1"/>
          <p:nvPr/>
        </p:nvSpPr>
        <p:spPr>
          <a:xfrm>
            <a:off x="6342088" y="2076524"/>
            <a:ext cx="484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2260395A-363F-4A3C-B141-48827316E351}"/>
              </a:ext>
            </a:extLst>
          </p:cNvPr>
          <p:cNvPicPr>
            <a:picLocks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584229" y="4940342"/>
            <a:ext cx="3456000" cy="1819963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B1E879C6-1696-4184-9960-BCD63D932B91}"/>
              </a:ext>
            </a:extLst>
          </p:cNvPr>
          <p:cNvPicPr>
            <a:picLocks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0451" y="4797457"/>
            <a:ext cx="3456000" cy="1886263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B62C8ED9-EA9F-49C3-AEFB-7EDDEB367B90}"/>
              </a:ext>
            </a:extLst>
          </p:cNvPr>
          <p:cNvSpPr txBox="1"/>
          <p:nvPr/>
        </p:nvSpPr>
        <p:spPr>
          <a:xfrm>
            <a:off x="3596179" y="4714737"/>
            <a:ext cx="1077603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0" b="1" dirty="0"/>
              <a:t>Tannic acid</a:t>
            </a:r>
            <a:endParaRPr lang="ko-KR" altLang="en-US" sz="1320" b="1" dirty="0"/>
          </a:p>
        </p:txBody>
      </p:sp>
      <p:sp>
        <p:nvSpPr>
          <p:cNvPr id="49" name="아래쪽 화살표 47">
            <a:extLst>
              <a:ext uri="{FF2B5EF4-FFF2-40B4-BE49-F238E27FC236}">
                <a16:creationId xmlns:a16="http://schemas.microsoft.com/office/drawing/2014/main" id="{388B1DC1-4594-49DD-91EF-5EA969EB1F1E}"/>
              </a:ext>
            </a:extLst>
          </p:cNvPr>
          <p:cNvSpPr/>
          <p:nvPr/>
        </p:nvSpPr>
        <p:spPr>
          <a:xfrm rot="2688206">
            <a:off x="3431808" y="4817756"/>
            <a:ext cx="107593" cy="20549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FA98C11-8BB2-4FD7-A3DA-BC9CD4C7244C}"/>
              </a:ext>
            </a:extLst>
          </p:cNvPr>
          <p:cNvSpPr txBox="1"/>
          <p:nvPr/>
        </p:nvSpPr>
        <p:spPr>
          <a:xfrm>
            <a:off x="8795139" y="4740505"/>
            <a:ext cx="1077603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0" b="1" dirty="0"/>
              <a:t>Tannic acid</a:t>
            </a:r>
            <a:endParaRPr lang="ko-KR" altLang="en-US" sz="1320" b="1" dirty="0"/>
          </a:p>
        </p:txBody>
      </p:sp>
      <p:sp>
        <p:nvSpPr>
          <p:cNvPr id="51" name="아래쪽 화살표 47">
            <a:extLst>
              <a:ext uri="{FF2B5EF4-FFF2-40B4-BE49-F238E27FC236}">
                <a16:creationId xmlns:a16="http://schemas.microsoft.com/office/drawing/2014/main" id="{18881134-32C4-4EE6-A534-B88AC7C21CCB}"/>
              </a:ext>
            </a:extLst>
          </p:cNvPr>
          <p:cNvSpPr/>
          <p:nvPr/>
        </p:nvSpPr>
        <p:spPr>
          <a:xfrm rot="2688206">
            <a:off x="8630768" y="4889222"/>
            <a:ext cx="107593" cy="20549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EBE54B9-3A66-4C8B-AF22-72E0B4965637}"/>
              </a:ext>
            </a:extLst>
          </p:cNvPr>
          <p:cNvSpPr txBox="1"/>
          <p:nvPr/>
        </p:nvSpPr>
        <p:spPr>
          <a:xfrm>
            <a:off x="1108205" y="4650793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F195ABB-E0E6-4273-B97B-5241E5B7BB5F}"/>
              </a:ext>
            </a:extLst>
          </p:cNvPr>
          <p:cNvSpPr txBox="1"/>
          <p:nvPr/>
        </p:nvSpPr>
        <p:spPr>
          <a:xfrm>
            <a:off x="6309053" y="4718388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9445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18017B18-2C8B-4FF9-9677-180C3A3F9416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0892" y="1383538"/>
            <a:ext cx="4752000" cy="2592000"/>
          </a:xfrm>
          <a:prstGeom prst="rect">
            <a:avLst/>
          </a:prstGeom>
        </p:spPr>
      </p:pic>
      <p:sp>
        <p:nvSpPr>
          <p:cNvPr id="10" name="아래쪽 화살표 16">
            <a:extLst>
              <a:ext uri="{FF2B5EF4-FFF2-40B4-BE49-F238E27FC236}">
                <a16:creationId xmlns:a16="http://schemas.microsoft.com/office/drawing/2014/main" id="{D42FF705-2B85-4794-9233-C75CCFCEDC6C}"/>
              </a:ext>
            </a:extLst>
          </p:cNvPr>
          <p:cNvSpPr/>
          <p:nvPr/>
        </p:nvSpPr>
        <p:spPr>
          <a:xfrm>
            <a:off x="4001349" y="3262707"/>
            <a:ext cx="89778" cy="21060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0DF1AE-6132-456B-A28E-8E33C2C4CE9A}"/>
              </a:ext>
            </a:extLst>
          </p:cNvPr>
          <p:cNvSpPr txBox="1"/>
          <p:nvPr/>
        </p:nvSpPr>
        <p:spPr>
          <a:xfrm>
            <a:off x="2376664" y="2977259"/>
            <a:ext cx="18637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g1</a:t>
            </a:r>
            <a:endParaRPr lang="ko-KR" altLang="en-US" sz="11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4958B3-380B-4C62-B97C-18AC1BCB295E}"/>
              </a:ext>
            </a:extLst>
          </p:cNvPr>
          <p:cNvSpPr txBox="1"/>
          <p:nvPr/>
        </p:nvSpPr>
        <p:spPr>
          <a:xfrm>
            <a:off x="3567615" y="2977259"/>
            <a:ext cx="16401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b1</a:t>
            </a:r>
            <a:endParaRPr lang="ko-KR" altLang="en-US" sz="11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E92F80A-7142-4BFA-A0BD-6CC77146B5EE}"/>
              </a:ext>
            </a:extLst>
          </p:cNvPr>
          <p:cNvSpPr txBox="1"/>
          <p:nvPr/>
        </p:nvSpPr>
        <p:spPr>
          <a:xfrm>
            <a:off x="4797995" y="2977259"/>
            <a:ext cx="17625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/>
              <a:t>Ginsenoside</a:t>
            </a:r>
            <a:r>
              <a:rPr lang="en-US" altLang="ko-KR" sz="1100" b="1" dirty="0"/>
              <a:t> Rg3</a:t>
            </a:r>
            <a:endParaRPr lang="ko-KR" altLang="en-US" sz="1100" b="1" dirty="0"/>
          </a:p>
        </p:txBody>
      </p:sp>
      <p:sp>
        <p:nvSpPr>
          <p:cNvPr id="14" name="아래쪽 화살표 21">
            <a:extLst>
              <a:ext uri="{FF2B5EF4-FFF2-40B4-BE49-F238E27FC236}">
                <a16:creationId xmlns:a16="http://schemas.microsoft.com/office/drawing/2014/main" id="{61894DAA-D82D-4BFF-AFB6-924BA552D451}"/>
              </a:ext>
            </a:extLst>
          </p:cNvPr>
          <p:cNvSpPr/>
          <p:nvPr/>
        </p:nvSpPr>
        <p:spPr>
          <a:xfrm>
            <a:off x="5207731" y="3259516"/>
            <a:ext cx="112963" cy="191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sp>
        <p:nvSpPr>
          <p:cNvPr id="15" name="아래쪽 화살표 22">
            <a:extLst>
              <a:ext uri="{FF2B5EF4-FFF2-40B4-BE49-F238E27FC236}">
                <a16:creationId xmlns:a16="http://schemas.microsoft.com/office/drawing/2014/main" id="{2F799500-89E9-4A6A-A9F5-38CF946D605E}"/>
              </a:ext>
            </a:extLst>
          </p:cNvPr>
          <p:cNvSpPr/>
          <p:nvPr/>
        </p:nvSpPr>
        <p:spPr>
          <a:xfrm>
            <a:off x="3336029" y="3262707"/>
            <a:ext cx="89778" cy="21060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FCA36D89-026A-4D4C-A37E-252BB37F72B3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89654" y="1666205"/>
            <a:ext cx="3456000" cy="2160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B05A490-4756-41E1-8FFC-60682B11EDE7}"/>
              </a:ext>
            </a:extLst>
          </p:cNvPr>
          <p:cNvSpPr txBox="1"/>
          <p:nvPr/>
        </p:nvSpPr>
        <p:spPr>
          <a:xfrm>
            <a:off x="9044922" y="1463083"/>
            <a:ext cx="1077603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0" b="1" dirty="0"/>
              <a:t>Tannic acid</a:t>
            </a:r>
            <a:endParaRPr lang="ko-KR" altLang="en-US" sz="1320" b="1" dirty="0"/>
          </a:p>
        </p:txBody>
      </p:sp>
      <p:sp>
        <p:nvSpPr>
          <p:cNvPr id="20" name="아래쪽 화살표 47">
            <a:extLst>
              <a:ext uri="{FF2B5EF4-FFF2-40B4-BE49-F238E27FC236}">
                <a16:creationId xmlns:a16="http://schemas.microsoft.com/office/drawing/2014/main" id="{7CE6A6B0-6DF0-49B2-9963-3A6CD0C0F64D}"/>
              </a:ext>
            </a:extLst>
          </p:cNvPr>
          <p:cNvSpPr/>
          <p:nvPr/>
        </p:nvSpPr>
        <p:spPr>
          <a:xfrm rot="2688206">
            <a:off x="8989500" y="1674269"/>
            <a:ext cx="107593" cy="20549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16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D33F85-6DC3-4BFA-856B-7D1A2FD12332}"/>
              </a:ext>
            </a:extLst>
          </p:cNvPr>
          <p:cNvSpPr txBox="1"/>
          <p:nvPr/>
        </p:nvSpPr>
        <p:spPr>
          <a:xfrm>
            <a:off x="1746346" y="957453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6F4034-F514-44E6-8B1A-8A2C697B9204}"/>
              </a:ext>
            </a:extLst>
          </p:cNvPr>
          <p:cNvSpPr txBox="1"/>
          <p:nvPr/>
        </p:nvSpPr>
        <p:spPr>
          <a:xfrm>
            <a:off x="6989654" y="896174"/>
            <a:ext cx="465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F122E0-5B77-4D6F-90EF-DA9C53BA6C7E}"/>
              </a:ext>
            </a:extLst>
          </p:cNvPr>
          <p:cNvSpPr txBox="1"/>
          <p:nvPr/>
        </p:nvSpPr>
        <p:spPr>
          <a:xfrm>
            <a:off x="49766" y="68411"/>
            <a:ext cx="3546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5202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A1F122E0-5B77-4D6F-90EF-DA9C53BA6C7E}"/>
              </a:ext>
            </a:extLst>
          </p:cNvPr>
          <p:cNvSpPr txBox="1"/>
          <p:nvPr/>
        </p:nvSpPr>
        <p:spPr>
          <a:xfrm>
            <a:off x="49766" y="68411"/>
            <a:ext cx="3546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7700CE8C-4503-4AEC-9EA1-8130070081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275346"/>
              </p:ext>
            </p:extLst>
          </p:nvPr>
        </p:nvGraphicFramePr>
        <p:xfrm>
          <a:off x="4038367" y="1433513"/>
          <a:ext cx="2797175" cy="1909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9" r:id="rId3" imgW="3473149" imgH="2189376" progId="Prism9.Document">
                  <p:embed/>
                </p:oleObj>
              </mc:Choice>
              <mc:Fallback>
                <p:oleObj name="Prism 9" r:id="rId3" imgW="3473149" imgH="2189376" progId="Prism9.Document">
                  <p:embed/>
                  <p:pic>
                    <p:nvPicPr>
                      <p:cNvPr id="22" name="개체 21">
                        <a:extLst>
                          <a:ext uri="{FF2B5EF4-FFF2-40B4-BE49-F238E27FC236}">
                            <a16:creationId xmlns:a16="http://schemas.microsoft.com/office/drawing/2014/main" id="{78727AE4-448B-4CFB-A3FF-6B772F78B4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38367" y="1433513"/>
                        <a:ext cx="2797175" cy="1909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9C8B81AE-4714-4C5E-8F04-5646CE8ABA51}"/>
              </a:ext>
            </a:extLst>
          </p:cNvPr>
          <p:cNvSpPr txBox="1"/>
          <p:nvPr/>
        </p:nvSpPr>
        <p:spPr>
          <a:xfrm rot="16200000">
            <a:off x="3175521" y="2144793"/>
            <a:ext cx="1092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Food intake</a:t>
            </a:r>
          </a:p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g/mouse/week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CC2B302-1C61-47C6-A2D6-529CD3CD4168}"/>
              </a:ext>
            </a:extLst>
          </p:cNvPr>
          <p:cNvSpPr txBox="1"/>
          <p:nvPr/>
        </p:nvSpPr>
        <p:spPr>
          <a:xfrm>
            <a:off x="3929982" y="313769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ED70D2-248E-4324-AEB3-3E2093EE59DF}"/>
              </a:ext>
            </a:extLst>
          </p:cNvPr>
          <p:cNvSpPr txBox="1"/>
          <p:nvPr/>
        </p:nvSpPr>
        <p:spPr>
          <a:xfrm>
            <a:off x="3875781" y="282701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68287A5-B871-49A0-A203-525717E4DDA5}"/>
              </a:ext>
            </a:extLst>
          </p:cNvPr>
          <p:cNvSpPr txBox="1"/>
          <p:nvPr/>
        </p:nvSpPr>
        <p:spPr>
          <a:xfrm>
            <a:off x="3805979" y="218500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156127-BD55-43D9-A5DF-AD16C969548C}"/>
              </a:ext>
            </a:extLst>
          </p:cNvPr>
          <p:cNvSpPr txBox="1"/>
          <p:nvPr/>
        </p:nvSpPr>
        <p:spPr>
          <a:xfrm>
            <a:off x="3817140" y="186611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D5DB015-7B92-46C5-86A4-27A2C26C9C49}"/>
              </a:ext>
            </a:extLst>
          </p:cNvPr>
          <p:cNvSpPr txBox="1"/>
          <p:nvPr/>
        </p:nvSpPr>
        <p:spPr>
          <a:xfrm>
            <a:off x="3812485" y="154725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AE37685-5A0A-454E-8E0F-A26922534A1A}"/>
              </a:ext>
            </a:extLst>
          </p:cNvPr>
          <p:cNvSpPr txBox="1"/>
          <p:nvPr/>
        </p:nvSpPr>
        <p:spPr>
          <a:xfrm>
            <a:off x="3815760" y="250422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76676E3-D6B0-41CE-AC37-BCE32D865B01}"/>
              </a:ext>
            </a:extLst>
          </p:cNvPr>
          <p:cNvSpPr txBox="1"/>
          <p:nvPr/>
        </p:nvSpPr>
        <p:spPr>
          <a:xfrm>
            <a:off x="4782000" y="3349910"/>
            <a:ext cx="1074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 Time (weeks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1A866C6-43D0-4793-AA5F-64C14A3BE7A2}"/>
              </a:ext>
            </a:extLst>
          </p:cNvPr>
          <p:cNvSpPr txBox="1"/>
          <p:nvPr/>
        </p:nvSpPr>
        <p:spPr>
          <a:xfrm>
            <a:off x="4181776" y="3219320"/>
            <a:ext cx="25093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      2     3      4      5     6     7      8     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74">
            <a:extLst>
              <a:ext uri="{FF2B5EF4-FFF2-40B4-BE49-F238E27FC236}">
                <a16:creationId xmlns:a16="http://schemas.microsoft.com/office/drawing/2014/main" id="{2AB8091F-0038-4151-B617-C563716152BB}"/>
              </a:ext>
            </a:extLst>
          </p:cNvPr>
          <p:cNvSpPr txBox="1"/>
          <p:nvPr/>
        </p:nvSpPr>
        <p:spPr>
          <a:xfrm>
            <a:off x="6529585" y="1624677"/>
            <a:ext cx="622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vehicle     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74">
            <a:extLst>
              <a:ext uri="{FF2B5EF4-FFF2-40B4-BE49-F238E27FC236}">
                <a16:creationId xmlns:a16="http://schemas.microsoft.com/office/drawing/2014/main" id="{A36ECB98-7E62-4820-9632-B21A2BB48A70}"/>
              </a:ext>
            </a:extLst>
          </p:cNvPr>
          <p:cNvSpPr txBox="1"/>
          <p:nvPr/>
        </p:nvSpPr>
        <p:spPr>
          <a:xfrm>
            <a:off x="6500551" y="2085219"/>
            <a:ext cx="9263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 vehicle     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74">
            <a:extLst>
              <a:ext uri="{FF2B5EF4-FFF2-40B4-BE49-F238E27FC236}">
                <a16:creationId xmlns:a16="http://schemas.microsoft.com/office/drawing/2014/main" id="{5F031CEA-0381-4438-A440-1016684594EF}"/>
              </a:ext>
            </a:extLst>
          </p:cNvPr>
          <p:cNvSpPr txBox="1"/>
          <p:nvPr/>
        </p:nvSpPr>
        <p:spPr>
          <a:xfrm>
            <a:off x="6519755" y="2742719"/>
            <a:ext cx="937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G/DKL2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243">
            <a:extLst>
              <a:ext uri="{FF2B5EF4-FFF2-40B4-BE49-F238E27FC236}">
                <a16:creationId xmlns:a16="http://schemas.microsoft.com/office/drawing/2014/main" id="{DDD9FC29-AFBD-49CC-9EB2-74731885C4FB}"/>
              </a:ext>
            </a:extLst>
          </p:cNvPr>
          <p:cNvCxnSpPr>
            <a:cxnSpLocks/>
          </p:cNvCxnSpPr>
          <p:nvPr/>
        </p:nvCxnSpPr>
        <p:spPr>
          <a:xfrm rot="16200000">
            <a:off x="6021746" y="2503749"/>
            <a:ext cx="81071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74">
            <a:extLst>
              <a:ext uri="{FF2B5EF4-FFF2-40B4-BE49-F238E27FC236}">
                <a16:creationId xmlns:a16="http://schemas.microsoft.com/office/drawing/2014/main" id="{869D4A53-CAFF-4BC7-9189-41504D99B4C9}"/>
              </a:ext>
            </a:extLst>
          </p:cNvPr>
          <p:cNvSpPr txBox="1"/>
          <p:nvPr/>
        </p:nvSpPr>
        <p:spPr>
          <a:xfrm>
            <a:off x="6532569" y="2532481"/>
            <a:ext cx="937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G/DKL1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74">
            <a:extLst>
              <a:ext uri="{FF2B5EF4-FFF2-40B4-BE49-F238E27FC236}">
                <a16:creationId xmlns:a16="http://schemas.microsoft.com/office/drawing/2014/main" id="{9AC676CF-B121-48FD-AA17-2B5E26431255}"/>
              </a:ext>
            </a:extLst>
          </p:cNvPr>
          <p:cNvSpPr txBox="1"/>
          <p:nvPr/>
        </p:nvSpPr>
        <p:spPr>
          <a:xfrm>
            <a:off x="6533959" y="2310845"/>
            <a:ext cx="937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G/DKL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74">
            <a:extLst>
              <a:ext uri="{FF2B5EF4-FFF2-40B4-BE49-F238E27FC236}">
                <a16:creationId xmlns:a16="http://schemas.microsoft.com/office/drawing/2014/main" id="{193BA81F-C782-4372-89D5-F18C1843288D}"/>
              </a:ext>
            </a:extLst>
          </p:cNvPr>
          <p:cNvSpPr txBox="1"/>
          <p:nvPr/>
        </p:nvSpPr>
        <p:spPr>
          <a:xfrm>
            <a:off x="6530448" y="1881543"/>
            <a:ext cx="891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G/DKL200     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243">
            <a:extLst>
              <a:ext uri="{FF2B5EF4-FFF2-40B4-BE49-F238E27FC236}">
                <a16:creationId xmlns:a16="http://schemas.microsoft.com/office/drawing/2014/main" id="{91B97B79-BD62-4C25-8A83-EA3420935BF0}"/>
              </a:ext>
            </a:extLst>
          </p:cNvPr>
          <p:cNvCxnSpPr>
            <a:cxnSpLocks/>
          </p:cNvCxnSpPr>
          <p:nvPr/>
        </p:nvCxnSpPr>
        <p:spPr>
          <a:xfrm rot="16200000">
            <a:off x="6255288" y="1855815"/>
            <a:ext cx="34382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978C4C7-7AE7-4AA0-936B-9581CA76C4C1}"/>
              </a:ext>
            </a:extLst>
          </p:cNvPr>
          <p:cNvSpPr txBox="1"/>
          <p:nvPr/>
        </p:nvSpPr>
        <p:spPr>
          <a:xfrm rot="16200000">
            <a:off x="6086614" y="1740093"/>
            <a:ext cx="5509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C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05E6D0B-0172-4936-A60F-08935099034D}"/>
              </a:ext>
            </a:extLst>
          </p:cNvPr>
          <p:cNvSpPr txBox="1"/>
          <p:nvPr/>
        </p:nvSpPr>
        <p:spPr>
          <a:xfrm rot="16200000">
            <a:off x="6102907" y="2345787"/>
            <a:ext cx="5509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0606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391</Words>
  <Application>Microsoft Office PowerPoint</Application>
  <PresentationFormat>와이드스크린</PresentationFormat>
  <Paragraphs>51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9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5" baseType="lpstr">
      <vt:lpstr>GulliverRM</vt:lpstr>
      <vt:lpstr>HY헤드라인M</vt:lpstr>
      <vt:lpstr>굴림</vt:lpstr>
      <vt:lpstr>궁서</vt:lpstr>
      <vt:lpstr>돋움</vt:lpstr>
      <vt:lpstr>맑은 고딕</vt:lpstr>
      <vt:lpstr>함초롬바탕</vt:lpstr>
      <vt:lpstr>Arial</vt:lpstr>
      <vt:lpstr>Times New Roman</vt:lpstr>
      <vt:lpstr>Office 테마</vt:lpstr>
      <vt:lpstr>Prism 9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5</cp:revision>
  <dcterms:created xsi:type="dcterms:W3CDTF">2023-05-09T01:29:25Z</dcterms:created>
  <dcterms:modified xsi:type="dcterms:W3CDTF">2023-05-25T04:08:42Z</dcterms:modified>
</cp:coreProperties>
</file>